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8" d="100"/>
          <a:sy n="88" d="100"/>
        </p:scale>
        <p:origin x="494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5069A0-F057-4C65-9A6D-00AC07E210A0}" type="datetimeFigureOut">
              <a:rPr lang="ko-KR" altLang="en-US" smtClean="0"/>
              <a:t>2023-10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B4BE4-1C03-4D3C-9332-A388CAA77D1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504477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5069A0-F057-4C65-9A6D-00AC07E210A0}" type="datetimeFigureOut">
              <a:rPr lang="ko-KR" altLang="en-US" smtClean="0"/>
              <a:t>2023-10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B4BE4-1C03-4D3C-9332-A388CAA77D1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068304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5069A0-F057-4C65-9A6D-00AC07E210A0}" type="datetimeFigureOut">
              <a:rPr lang="ko-KR" altLang="en-US" smtClean="0"/>
              <a:t>2023-10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B4BE4-1C03-4D3C-9332-A388CAA77D1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618087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5069A0-F057-4C65-9A6D-00AC07E210A0}" type="datetimeFigureOut">
              <a:rPr lang="ko-KR" altLang="en-US" smtClean="0"/>
              <a:t>2023-10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B4BE4-1C03-4D3C-9332-A388CAA77D1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442313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5069A0-F057-4C65-9A6D-00AC07E210A0}" type="datetimeFigureOut">
              <a:rPr lang="ko-KR" altLang="en-US" smtClean="0"/>
              <a:t>2023-10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B4BE4-1C03-4D3C-9332-A388CAA77D1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380263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5069A0-F057-4C65-9A6D-00AC07E210A0}" type="datetimeFigureOut">
              <a:rPr lang="ko-KR" altLang="en-US" smtClean="0"/>
              <a:t>2023-10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B4BE4-1C03-4D3C-9332-A388CAA77D1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702606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5069A0-F057-4C65-9A6D-00AC07E210A0}" type="datetimeFigureOut">
              <a:rPr lang="ko-KR" altLang="en-US" smtClean="0"/>
              <a:t>2023-10-25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B4BE4-1C03-4D3C-9332-A388CAA77D1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678290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5069A0-F057-4C65-9A6D-00AC07E210A0}" type="datetimeFigureOut">
              <a:rPr lang="ko-KR" altLang="en-US" smtClean="0"/>
              <a:t>2023-10-2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B4BE4-1C03-4D3C-9332-A388CAA77D1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143180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5069A0-F057-4C65-9A6D-00AC07E210A0}" type="datetimeFigureOut">
              <a:rPr lang="ko-KR" altLang="en-US" smtClean="0"/>
              <a:t>2023-10-25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B4BE4-1C03-4D3C-9332-A388CAA77D1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23274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5069A0-F057-4C65-9A6D-00AC07E210A0}" type="datetimeFigureOut">
              <a:rPr lang="ko-KR" altLang="en-US" smtClean="0"/>
              <a:t>2023-10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B4BE4-1C03-4D3C-9332-A388CAA77D1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945162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5069A0-F057-4C65-9A6D-00AC07E210A0}" type="datetimeFigureOut">
              <a:rPr lang="ko-KR" altLang="en-US" smtClean="0"/>
              <a:t>2023-10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B4BE4-1C03-4D3C-9332-A388CAA77D1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149732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5069A0-F057-4C65-9A6D-00AC07E210A0}" type="datetimeFigureOut">
              <a:rPr lang="ko-KR" altLang="en-US" smtClean="0"/>
              <a:t>2023-10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3B4BE4-1C03-4D3C-9332-A388CAA77D1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076320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표 7"/>
          <p:cNvGraphicFramePr>
            <a:graphicFrameLocks noGrp="1"/>
          </p:cNvGraphicFramePr>
          <p:nvPr>
            <p:extLst/>
          </p:nvPr>
        </p:nvGraphicFramePr>
        <p:xfrm>
          <a:off x="3138467" y="2290926"/>
          <a:ext cx="5750771" cy="1461897"/>
        </p:xfrm>
        <a:graphic>
          <a:graphicData uri="http://schemas.openxmlformats.org/drawingml/2006/table">
            <a:tbl>
              <a:tblPr firstRow="1" firstCol="1" bandRow="1"/>
              <a:tblGrid>
                <a:gridCol w="737100">
                  <a:extLst>
                    <a:ext uri="{9D8B030D-6E8A-4147-A177-3AD203B41FA5}">
                      <a16:colId xmlns:a16="http://schemas.microsoft.com/office/drawing/2014/main" val="2798739349"/>
                    </a:ext>
                  </a:extLst>
                </a:gridCol>
                <a:gridCol w="2093190">
                  <a:extLst>
                    <a:ext uri="{9D8B030D-6E8A-4147-A177-3AD203B41FA5}">
                      <a16:colId xmlns:a16="http://schemas.microsoft.com/office/drawing/2014/main" val="254270902"/>
                    </a:ext>
                  </a:extLst>
                </a:gridCol>
                <a:gridCol w="2093190">
                  <a:extLst>
                    <a:ext uri="{9D8B030D-6E8A-4147-A177-3AD203B41FA5}">
                      <a16:colId xmlns:a16="http://schemas.microsoft.com/office/drawing/2014/main" val="2580089814"/>
                    </a:ext>
                  </a:extLst>
                </a:gridCol>
                <a:gridCol w="827291">
                  <a:extLst>
                    <a:ext uri="{9D8B030D-6E8A-4147-A177-3AD203B41FA5}">
                      <a16:colId xmlns:a16="http://schemas.microsoft.com/office/drawing/2014/main" val="4026595934"/>
                    </a:ext>
                  </a:extLst>
                </a:gridCol>
              </a:tblGrid>
              <a:tr h="269875"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Gene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Direction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Sequence (5`→3`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Size (bp)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55648914"/>
                  </a:ext>
                </a:extLst>
              </a:tr>
              <a:tr h="269875">
                <a:tc rowSpan="2"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NDV check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Forward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CACAATTCCAAGATAACCGGAG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327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2523816"/>
                  </a:ext>
                </a:extLst>
              </a:tr>
              <a:tr h="269875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Reverse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GCTGCCACAATCAGATGCCTTTG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34298554"/>
                  </a:ext>
                </a:extLst>
              </a:tr>
              <a:tr h="269875">
                <a:tc rowSpan="2"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Vaccinia virus check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Forward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ATGACGATGAAAATGATGGTACATA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,059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81385332"/>
                  </a:ext>
                </a:extLst>
              </a:tr>
              <a:tr h="269875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Reverse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TCCAATACTACTGTAGTTGTAAGG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24540055"/>
                  </a:ext>
                </a:extLst>
              </a:tr>
            </a:tbl>
          </a:graphicData>
        </a:graphic>
      </p:graphicFrame>
      <p:sp>
        <p:nvSpPr>
          <p:cNvPr id="9" name="Rectangle 1"/>
          <p:cNvSpPr>
            <a:spLocks noChangeArrowheads="1"/>
          </p:cNvSpPr>
          <p:nvPr/>
        </p:nvSpPr>
        <p:spPr bwMode="auto">
          <a:xfrm>
            <a:off x="3138467" y="1939215"/>
            <a:ext cx="4916806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eaLnBrk="0" fontAlgn="base" latinLnBrk="0" hangingPunct="0">
              <a:spcBef>
                <a:spcPct val="0"/>
              </a:spcBef>
              <a:spcAft>
                <a:spcPct val="0"/>
              </a:spcAft>
            </a:pPr>
            <a:r>
              <a:rPr lang="en-US" altLang="ko-KR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kumimoji="0" lang="en-US" altLang="ko-KR" sz="1000" b="1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data 1</a:t>
            </a:r>
            <a:r>
              <a:rPr kumimoji="0" lang="en-US" altLang="ko-KR" sz="10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.</a:t>
            </a:r>
            <a:r>
              <a:rPr kumimoji="0" lang="en-US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The primers used in this study to identify the viral genome</a:t>
            </a:r>
            <a:endParaRPr kumimoji="0" lang="en-US" altLang="ko-K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697145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3</Words>
  <Application>Microsoft Office PowerPoint</Application>
  <PresentationFormat>와이드스크린</PresentationFormat>
  <Paragraphs>17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Bo-Kyoung Jung</dc:creator>
  <cp:lastModifiedBy>Bo-Kyoung Jung</cp:lastModifiedBy>
  <cp:revision>2</cp:revision>
  <dcterms:created xsi:type="dcterms:W3CDTF">2023-10-25T07:54:55Z</dcterms:created>
  <dcterms:modified xsi:type="dcterms:W3CDTF">2023-10-25T07:55:11Z</dcterms:modified>
</cp:coreProperties>
</file>